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5" d="100"/>
          <a:sy n="85" d="100"/>
        </p:scale>
        <p:origin x="590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A854E3CC-5F1B-40D4-BAF4-B557CAAC54F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Podtytuł 2">
            <a:extLst>
              <a:ext uri="{FF2B5EF4-FFF2-40B4-BE49-F238E27FC236}">
                <a16:creationId xmlns:a16="http://schemas.microsoft.com/office/drawing/2014/main" id="{7CB55AE0-74E4-4893-9407-7213932FE8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83EF7885-A863-4ADC-BD6E-442AE4893D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D60BA-EF01-42DA-AC5C-1CE02CE879FD}" type="datetimeFigureOut">
              <a:rPr lang="pl-PL" smtClean="0"/>
              <a:t>23.05.2024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EC5D68B0-9579-4B5B-ADB9-D7E01CF873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C45109F0-213E-4165-8E9A-76F84D74F6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CD9BC-1DB2-461D-BF21-4E32E1FFE83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75093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0424B875-5FB3-43F4-9F46-38039FDD49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4691532D-6C40-4988-AF40-36B730F36D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E801CA7C-AFE6-4AE9-B932-C5D8C3B56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D60BA-EF01-42DA-AC5C-1CE02CE879FD}" type="datetimeFigureOut">
              <a:rPr lang="pl-PL" smtClean="0"/>
              <a:t>23.05.2024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F7CA99FC-4772-45E8-9916-08BAEBC265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88CAABB4-C2E3-4757-93CE-93557F69DA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CD9BC-1DB2-461D-BF21-4E32E1FFE83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023365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>
            <a:extLst>
              <a:ext uri="{FF2B5EF4-FFF2-40B4-BE49-F238E27FC236}">
                <a16:creationId xmlns:a16="http://schemas.microsoft.com/office/drawing/2014/main" id="{09B8F822-30D7-431F-AC8B-3CB8BF08FF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488E48C9-B0C5-45B3-9CA6-21914375D7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B807EAED-8443-49D4-B040-8709F3EBF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D60BA-EF01-42DA-AC5C-1CE02CE879FD}" type="datetimeFigureOut">
              <a:rPr lang="pl-PL" smtClean="0"/>
              <a:t>23.05.2024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F38D0B58-0788-417F-ADB1-AC3744128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272B18CB-DCCC-41F8-A0A5-AE28069D0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CD9BC-1DB2-461D-BF21-4E32E1FFE83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184180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D9DC227B-1B17-47E7-9770-2BFA2F53BF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8CA2166A-0584-4324-A16D-C723A92E1C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99EB5C75-B464-44E0-BB16-B94B60CA95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D60BA-EF01-42DA-AC5C-1CE02CE879FD}" type="datetimeFigureOut">
              <a:rPr lang="pl-PL" smtClean="0"/>
              <a:t>23.05.2024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14F82FF3-D996-449E-A026-321DF9367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D3ADB6CB-0084-4FCB-8DBA-BB2C62C6C1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CD9BC-1DB2-461D-BF21-4E32E1FFE83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129222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ED45C0FA-6470-40AE-8403-5F2FF34550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B5C6BE0A-140E-447F-9991-B9781B1011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CCEC6EE5-B4D4-4E17-B702-C35EB826C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D60BA-EF01-42DA-AC5C-1CE02CE879FD}" type="datetimeFigureOut">
              <a:rPr lang="pl-PL" smtClean="0"/>
              <a:t>23.05.2024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E06E95FA-73DA-48CB-867D-AED1C23C8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1F157C37-A15A-4A4D-BE18-9349659EC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CD9BC-1DB2-461D-BF21-4E32E1FFE83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728458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55E4AA64-AEA8-4296-BA11-A9332A5690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A70F919B-BFAD-4EA0-8099-05EFCA6445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3BFCC008-D2A1-4790-8B14-AF4BB87EB3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70A6D51E-8002-4473-95E7-FEFF4B40A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D60BA-EF01-42DA-AC5C-1CE02CE879FD}" type="datetimeFigureOut">
              <a:rPr lang="pl-PL" smtClean="0"/>
              <a:t>23.05.2024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5EA6DA88-3F5A-4F81-86F2-9EDE4D1BD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DA5F0B8A-86A0-4FC8-99B1-31137B1F96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CD9BC-1DB2-461D-BF21-4E32E1FFE83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9230378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DAF9E256-C359-4585-9CC5-F0431B7BD0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809FCFB3-A717-4759-9767-49E8D1D45B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73C74317-577E-466E-BF07-A6E02D5928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>
            <a:extLst>
              <a:ext uri="{FF2B5EF4-FFF2-40B4-BE49-F238E27FC236}">
                <a16:creationId xmlns:a16="http://schemas.microsoft.com/office/drawing/2014/main" id="{D559C914-A173-4AE0-9A6B-87049B9A42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Symbol zastępczy zawartości 5">
            <a:extLst>
              <a:ext uri="{FF2B5EF4-FFF2-40B4-BE49-F238E27FC236}">
                <a16:creationId xmlns:a16="http://schemas.microsoft.com/office/drawing/2014/main" id="{B0F8BCA5-0EF2-4F14-8057-855C6BDABC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>
            <a:extLst>
              <a:ext uri="{FF2B5EF4-FFF2-40B4-BE49-F238E27FC236}">
                <a16:creationId xmlns:a16="http://schemas.microsoft.com/office/drawing/2014/main" id="{B1ED2C3F-6DD9-4C1B-8F17-4822DFDBF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D60BA-EF01-42DA-AC5C-1CE02CE879FD}" type="datetimeFigureOut">
              <a:rPr lang="pl-PL" smtClean="0"/>
              <a:t>23.05.2024</a:t>
            </a:fld>
            <a:endParaRPr lang="pl-PL"/>
          </a:p>
        </p:txBody>
      </p:sp>
      <p:sp>
        <p:nvSpPr>
          <p:cNvPr id="8" name="Symbol zastępczy stopki 7">
            <a:extLst>
              <a:ext uri="{FF2B5EF4-FFF2-40B4-BE49-F238E27FC236}">
                <a16:creationId xmlns:a16="http://schemas.microsoft.com/office/drawing/2014/main" id="{7F52D5E6-F7CB-418F-B7D7-8353C8B75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>
            <a:extLst>
              <a:ext uri="{FF2B5EF4-FFF2-40B4-BE49-F238E27FC236}">
                <a16:creationId xmlns:a16="http://schemas.microsoft.com/office/drawing/2014/main" id="{B9DC3FB1-3543-4BF0-8D0E-E77F319E6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CD9BC-1DB2-461D-BF21-4E32E1FFE83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1897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F12EF5AD-190B-45E0-B4E3-241F58A858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2">
            <a:extLst>
              <a:ext uri="{FF2B5EF4-FFF2-40B4-BE49-F238E27FC236}">
                <a16:creationId xmlns:a16="http://schemas.microsoft.com/office/drawing/2014/main" id="{5E741FAE-1F82-491C-85F9-A19DE3DB9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D60BA-EF01-42DA-AC5C-1CE02CE879FD}" type="datetimeFigureOut">
              <a:rPr lang="pl-PL" smtClean="0"/>
              <a:t>23.05.2024</a:t>
            </a:fld>
            <a:endParaRPr lang="pl-PL"/>
          </a:p>
        </p:txBody>
      </p:sp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id="{B0C8AE75-A947-4D72-A2E9-8F19C5074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>
            <a:extLst>
              <a:ext uri="{FF2B5EF4-FFF2-40B4-BE49-F238E27FC236}">
                <a16:creationId xmlns:a16="http://schemas.microsoft.com/office/drawing/2014/main" id="{417CCE82-31C9-496A-ABA3-524C92D807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CD9BC-1DB2-461D-BF21-4E32E1FFE83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6959405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>
            <a:extLst>
              <a:ext uri="{FF2B5EF4-FFF2-40B4-BE49-F238E27FC236}">
                <a16:creationId xmlns:a16="http://schemas.microsoft.com/office/drawing/2014/main" id="{7727CE6C-DC5A-4E5E-946E-5DDB402199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D60BA-EF01-42DA-AC5C-1CE02CE879FD}" type="datetimeFigureOut">
              <a:rPr lang="pl-PL" smtClean="0"/>
              <a:t>23.05.2024</a:t>
            </a:fld>
            <a:endParaRPr lang="pl-PL"/>
          </a:p>
        </p:txBody>
      </p:sp>
      <p:sp>
        <p:nvSpPr>
          <p:cNvPr id="3" name="Symbol zastępczy stopki 2">
            <a:extLst>
              <a:ext uri="{FF2B5EF4-FFF2-40B4-BE49-F238E27FC236}">
                <a16:creationId xmlns:a16="http://schemas.microsoft.com/office/drawing/2014/main" id="{0A328F3D-AF41-4170-98BE-E0104E22D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>
            <a:extLst>
              <a:ext uri="{FF2B5EF4-FFF2-40B4-BE49-F238E27FC236}">
                <a16:creationId xmlns:a16="http://schemas.microsoft.com/office/drawing/2014/main" id="{636E8A3C-DDB2-4ED0-874D-93A28F112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CD9BC-1DB2-461D-BF21-4E32E1FFE83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33105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B04C6FC5-145A-4C4E-AAE4-7CF6C8E6BE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0A01A8B4-5513-43AF-934E-9DC6592F05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C47A76F8-8CC3-43D1-8DA9-6C2612470B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63BD9357-F76D-472F-87CE-3942C1BAFE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D60BA-EF01-42DA-AC5C-1CE02CE879FD}" type="datetimeFigureOut">
              <a:rPr lang="pl-PL" smtClean="0"/>
              <a:t>23.05.2024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BAE64718-6A34-4B2D-BE9C-60F34996E9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7DA59D2F-245E-495D-B754-C630863551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CD9BC-1DB2-461D-BF21-4E32E1FFE83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362758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FD5FE01D-4694-4008-92B1-6A11C19E9E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>
            <a:extLst>
              <a:ext uri="{FF2B5EF4-FFF2-40B4-BE49-F238E27FC236}">
                <a16:creationId xmlns:a16="http://schemas.microsoft.com/office/drawing/2014/main" id="{BDB92740-86AD-4570-B4BA-B474165126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0CA67807-C5B9-46ED-B4BC-652383ED7F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197CC3F7-B753-443D-9F6E-47B479A08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D60BA-EF01-42DA-AC5C-1CE02CE879FD}" type="datetimeFigureOut">
              <a:rPr lang="pl-PL" smtClean="0"/>
              <a:t>23.05.2024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76C56EAA-CCAB-4C00-8A06-DDD0075CB3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0568D12F-BEDA-47CA-9560-B040D660D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CD9BC-1DB2-461D-BF21-4E32E1FFE83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28000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>
            <a:extLst>
              <a:ext uri="{FF2B5EF4-FFF2-40B4-BE49-F238E27FC236}">
                <a16:creationId xmlns:a16="http://schemas.microsoft.com/office/drawing/2014/main" id="{AD47E331-CF94-491D-9C3B-A387443BFE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2BEECF09-CD1A-41D0-86CD-AD6570657C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6379001C-635D-4DCD-B468-9EFFCE2858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8D60BA-EF01-42DA-AC5C-1CE02CE879FD}" type="datetimeFigureOut">
              <a:rPr lang="pl-PL" smtClean="0"/>
              <a:t>23.05.2024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CAFBDA0C-3454-412A-A95D-CE49283B9D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7ECC3E04-CB0A-4AC1-983E-BDE92B6FE5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CD9BC-1DB2-461D-BF21-4E32E1FFE83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8455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braz 3">
            <a:extLst>
              <a:ext uri="{FF2B5EF4-FFF2-40B4-BE49-F238E27FC236}">
                <a16:creationId xmlns:a16="http://schemas.microsoft.com/office/drawing/2014/main" id="{553A562D-1D92-4687-BFE1-96427EBEC4E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6160" y="65895"/>
            <a:ext cx="11840115" cy="679210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4443C2E-60F9-E33F-8029-2724114F0B8B}"/>
              </a:ext>
            </a:extLst>
          </p:cNvPr>
          <p:cNvSpPr txBox="1"/>
          <p:nvPr/>
        </p:nvSpPr>
        <p:spPr>
          <a:xfrm>
            <a:off x="161364" y="65895"/>
            <a:ext cx="88571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</a:t>
            </a:r>
            <a:r>
              <a:rPr lang="en-US" altLang="zh-CN" dirty="0"/>
              <a:t>igure S4: </a:t>
            </a:r>
            <a:r>
              <a:rPr lang="en-US" dirty="0"/>
              <a:t>Phylogenetic analysis of </a:t>
            </a:r>
            <a:r>
              <a:rPr lang="en-US" i="1" dirty="0"/>
              <a:t>Salmonella</a:t>
            </a:r>
            <a:r>
              <a:rPr lang="en-US" dirty="0"/>
              <a:t> </a:t>
            </a:r>
            <a:r>
              <a:rPr lang="en-US" i="1" dirty="0"/>
              <a:t>enterica</a:t>
            </a:r>
            <a:r>
              <a:rPr lang="en-US" dirty="0"/>
              <a:t> subsp. </a:t>
            </a:r>
            <a:r>
              <a:rPr lang="en-US" i="1" dirty="0" err="1"/>
              <a:t>diarizonae</a:t>
            </a:r>
            <a:r>
              <a:rPr lang="en-US" dirty="0"/>
              <a:t> </a:t>
            </a:r>
            <a:r>
              <a:rPr lang="en-US" dirty="0" err="1"/>
              <a:t>IIIb</a:t>
            </a:r>
            <a:r>
              <a:rPr lang="en-US" dirty="0"/>
              <a:t> 58:r:z</a:t>
            </a:r>
            <a:r>
              <a:rPr lang="en-US" baseline="-25000" dirty="0"/>
              <a:t>53</a:t>
            </a:r>
            <a:r>
              <a:rPr lang="en-US" dirty="0"/>
              <a:t> strain as a whole-genome-based tree inferred using the TYGS strain-typing server.</a:t>
            </a:r>
          </a:p>
        </p:txBody>
      </p:sp>
    </p:spTree>
    <p:extLst>
      <p:ext uri="{BB962C8B-B14F-4D97-AF65-F5344CB8AC3E}">
        <p14:creationId xmlns:p14="http://schemas.microsoft.com/office/powerpoint/2010/main" val="7768615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49085D4D-FB62-45A3-A81E-E07A8C0AE2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EC6E529A-9960-4DCA-9485-BB43730B18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pl-PL"/>
          </a:p>
        </p:txBody>
      </p:sp>
      <p:pic>
        <p:nvPicPr>
          <p:cNvPr id="4" name="Obraz 3">
            <a:extLst>
              <a:ext uri="{FF2B5EF4-FFF2-40B4-BE49-F238E27FC236}">
                <a16:creationId xmlns:a16="http://schemas.microsoft.com/office/drawing/2014/main" id="{28679ED1-0E46-4910-AA43-0460811CCCC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7973" y="137674"/>
            <a:ext cx="11733413" cy="63552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6703239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</TotalTime>
  <Words>29</Words>
  <Application>Microsoft Office PowerPoint</Application>
  <PresentationFormat>Widescreen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Motyw pakietu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Joanna Pławińska-Czarnak</dc:creator>
  <cp:lastModifiedBy>MDPI</cp:lastModifiedBy>
  <cp:revision>3</cp:revision>
  <dcterms:created xsi:type="dcterms:W3CDTF">2024-03-26T12:44:27Z</dcterms:created>
  <dcterms:modified xsi:type="dcterms:W3CDTF">2024-05-22T16:43:50Z</dcterms:modified>
</cp:coreProperties>
</file>